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6858000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9" d="100"/>
          <a:sy n="69" d="100"/>
        </p:scale>
        <p:origin x="193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178222"/>
            <a:ext cx="5829300" cy="250642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3781306"/>
            <a:ext cx="5143500" cy="173816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7/01/2020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0221586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7/01/2020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7401220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383297"/>
            <a:ext cx="1478756" cy="610108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383297"/>
            <a:ext cx="4350544" cy="6101085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7/01/2020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332887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7/01/2020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970720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794831"/>
            <a:ext cx="5915025" cy="2994714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4817876"/>
            <a:ext cx="5915025" cy="15748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7/01/2020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924331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916484"/>
            <a:ext cx="2914650" cy="456789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916484"/>
            <a:ext cx="2914650" cy="456789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7/01/2020</a:t>
            </a:fld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4399340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83299"/>
            <a:ext cx="5915025" cy="1391534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764832"/>
            <a:ext cx="2901255" cy="86491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629749"/>
            <a:ext cx="2901255" cy="3867965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764832"/>
            <a:ext cx="2915543" cy="864917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629749"/>
            <a:ext cx="2915543" cy="3867965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7/01/2020</a:t>
            </a:fld>
            <a:endParaRPr lang="es-C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2046794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7/01/2020</a:t>
            </a:fld>
            <a:endParaRPr lang="es-C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282964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7/01/2020</a:t>
            </a:fld>
            <a:endParaRPr lang="es-C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587764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79954"/>
            <a:ext cx="2211884" cy="16798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036570"/>
            <a:ext cx="3471863" cy="511617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159794"/>
            <a:ext cx="2211884" cy="4001285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7/01/2020</a:t>
            </a:fld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006087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79954"/>
            <a:ext cx="2211884" cy="16798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036570"/>
            <a:ext cx="3471863" cy="5116178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159794"/>
            <a:ext cx="2211884" cy="4001285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FFA98-652E-4258-835A-B81DCFDBC90E}" type="datetimeFigureOut">
              <a:rPr lang="es-CO" smtClean="0"/>
              <a:t>7/01/2020</a:t>
            </a:fld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5152414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383299"/>
            <a:ext cx="5915025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916484"/>
            <a:ext cx="5915025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6672698"/>
            <a:ext cx="1543050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9FFA98-652E-4258-835A-B81DCFDBC90E}" type="datetimeFigureOut">
              <a:rPr lang="es-CO" smtClean="0"/>
              <a:t>7/01/2020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6672698"/>
            <a:ext cx="2314575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6672698"/>
            <a:ext cx="1543050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4596B-1C66-4A71-B737-E90BC6CF1155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769765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upo 21">
            <a:extLst>
              <a:ext uri="{FF2B5EF4-FFF2-40B4-BE49-F238E27FC236}">
                <a16:creationId xmlns:a16="http://schemas.microsoft.com/office/drawing/2014/main" id="{777D9BEF-4C0A-48B1-BDCD-A837D6973D7F}"/>
              </a:ext>
            </a:extLst>
          </p:cNvPr>
          <p:cNvGrpSpPr/>
          <p:nvPr/>
        </p:nvGrpSpPr>
        <p:grpSpPr>
          <a:xfrm>
            <a:off x="54592" y="151774"/>
            <a:ext cx="6803408" cy="5943472"/>
            <a:chOff x="54592" y="650305"/>
            <a:chExt cx="6803408" cy="5943472"/>
          </a:xfrm>
        </p:grpSpPr>
        <p:pic>
          <p:nvPicPr>
            <p:cNvPr id="23" name="Imagen 22">
              <a:extLst>
                <a:ext uri="{FF2B5EF4-FFF2-40B4-BE49-F238E27FC236}">
                  <a16:creationId xmlns:a16="http://schemas.microsoft.com/office/drawing/2014/main" id="{3A9C958E-95E9-4267-8FFD-02F93B7E86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033" b="10016"/>
            <a:stretch/>
          </p:blipFill>
          <p:spPr>
            <a:xfrm>
              <a:off x="54592" y="665996"/>
              <a:ext cx="6457894" cy="3957244"/>
            </a:xfrm>
            <a:prstGeom prst="rect">
              <a:avLst/>
            </a:prstGeom>
          </p:spPr>
        </p:pic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2718CCBD-28DD-4977-B924-5E595CB80A4C}"/>
                </a:ext>
              </a:extLst>
            </p:cNvPr>
            <p:cNvSpPr txBox="1"/>
            <p:nvPr/>
          </p:nvSpPr>
          <p:spPr>
            <a:xfrm>
              <a:off x="182105" y="650305"/>
              <a:ext cx="6221667" cy="1892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O" sz="630" dirty="0"/>
                <a:t>1     2     3    4     5      6    7     8     9    10  11  12   13  14   15   16   17  18   19  20   21  22  23   24   25  26   27  28   29  30   31   32  33  34   35   36  37  38   39  40   41   42   43  44   45  46  47   48  </a:t>
              </a: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6936C470-57EB-400A-B498-B3B315EB53E4}"/>
                </a:ext>
              </a:extLst>
            </p:cNvPr>
            <p:cNvSpPr txBox="1"/>
            <p:nvPr/>
          </p:nvSpPr>
          <p:spPr>
            <a:xfrm>
              <a:off x="179452" y="2583833"/>
              <a:ext cx="6246443" cy="1892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O" sz="630" dirty="0"/>
                <a:t>49   50   51  52   53  54   55   56  57   58  59   60   61  62  63   64  65  66   67   68   69  70  71   72  73   74  75   76   77  78  79   80   81   82  83  84   85  86  87   88   89  90   91   92  93  94  95  Cl-</a:t>
              </a:r>
            </a:p>
          </p:txBody>
        </p:sp>
        <p:pic>
          <p:nvPicPr>
            <p:cNvPr id="26" name="Imagen 25">
              <a:extLst>
                <a:ext uri="{FF2B5EF4-FFF2-40B4-BE49-F238E27FC236}">
                  <a16:creationId xmlns:a16="http://schemas.microsoft.com/office/drawing/2014/main" id="{523E579C-28F2-4658-8108-C9E42D214284}"/>
                </a:ext>
              </a:extLst>
            </p:cNvPr>
            <p:cNvPicPr/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623" t="46724" r="1" b="32454"/>
            <a:stretch/>
          </p:blipFill>
          <p:spPr bwMode="auto">
            <a:xfrm>
              <a:off x="6520806" y="1170260"/>
              <a:ext cx="337194" cy="806579"/>
            </a:xfrm>
            <a:prstGeom prst="rect">
              <a:avLst/>
            </a:prstGeom>
            <a:noFill/>
          </p:spPr>
        </p:pic>
        <p:pic>
          <p:nvPicPr>
            <p:cNvPr id="27" name="Imagen 26">
              <a:extLst>
                <a:ext uri="{FF2B5EF4-FFF2-40B4-BE49-F238E27FC236}">
                  <a16:creationId xmlns:a16="http://schemas.microsoft.com/office/drawing/2014/main" id="{B4E10980-F33C-4E92-B039-B97CFD8A64B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2" t="10881" r="45219" b="59129"/>
            <a:stretch/>
          </p:blipFill>
          <p:spPr>
            <a:xfrm>
              <a:off x="54592" y="4663785"/>
              <a:ext cx="3752420" cy="1929992"/>
            </a:xfrm>
            <a:prstGeom prst="rect">
              <a:avLst/>
            </a:prstGeom>
          </p:spPr>
        </p:pic>
        <p:sp>
          <p:nvSpPr>
            <p:cNvPr id="28" name="CuadroTexto 27">
              <a:extLst>
                <a:ext uri="{FF2B5EF4-FFF2-40B4-BE49-F238E27FC236}">
                  <a16:creationId xmlns:a16="http://schemas.microsoft.com/office/drawing/2014/main" id="{9D84A08D-3735-4049-AF1F-B05A84AFE1A6}"/>
                </a:ext>
              </a:extLst>
            </p:cNvPr>
            <p:cNvSpPr txBox="1"/>
            <p:nvPr/>
          </p:nvSpPr>
          <p:spPr>
            <a:xfrm>
              <a:off x="236216" y="4745339"/>
              <a:ext cx="36391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O" sz="600" dirty="0"/>
                <a:t>96  97   98    99  100  101 102  103 104 105  106 107  108 109  110 111 112  113  114  115 116  117 118  119 120</a:t>
              </a:r>
            </a:p>
          </p:txBody>
        </p:sp>
      </p:grpSp>
      <p:sp>
        <p:nvSpPr>
          <p:cNvPr id="29" name="Rectángulo 28">
            <a:extLst>
              <a:ext uri="{FF2B5EF4-FFF2-40B4-BE49-F238E27FC236}">
                <a16:creationId xmlns:a16="http://schemas.microsoft.com/office/drawing/2014/main" id="{A8214835-902C-41A9-87A0-69FFF241249E}"/>
              </a:ext>
            </a:extLst>
          </p:cNvPr>
          <p:cNvSpPr/>
          <p:nvPr/>
        </p:nvSpPr>
        <p:spPr>
          <a:xfrm>
            <a:off x="582928" y="6175536"/>
            <a:ext cx="5704417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400" b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Figure S3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. PCR analysis showing the presence of the </a:t>
            </a:r>
            <a:r>
              <a:rPr lang="en-AU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EF1a </a:t>
            </a:r>
            <a:r>
              <a:rPr lang="en-AU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gene on 113 from the 120 isolates obtained in this study.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PCR product visualization was carried out following electrophoresis in a 1% agarose gel.   </a:t>
            </a:r>
            <a:r>
              <a:rPr lang="en-US" sz="1400" i="1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</a:t>
            </a:r>
            <a:endParaRPr lang="es-CO" sz="1400" dirty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172345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1</TotalTime>
  <Words>159</Words>
  <Application>Microsoft Office PowerPoint</Application>
  <PresentationFormat>Personalizado</PresentationFormat>
  <Paragraphs>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uricio Soto Suárez</dc:creator>
  <cp:lastModifiedBy>Mauricio Soto Suárez</cp:lastModifiedBy>
  <cp:revision>14</cp:revision>
  <dcterms:created xsi:type="dcterms:W3CDTF">2019-03-04T19:13:07Z</dcterms:created>
  <dcterms:modified xsi:type="dcterms:W3CDTF">2020-01-07T13:51:41Z</dcterms:modified>
</cp:coreProperties>
</file>